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866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857"/>
    <p:restoredTop sz="95551"/>
  </p:normalViewPr>
  <p:slideViewPr>
    <p:cSldViewPr snapToGrid="0" snapToObjects="1">
      <p:cViewPr varScale="1">
        <p:scale>
          <a:sx n="80" d="100"/>
          <a:sy n="80" d="100"/>
        </p:scale>
        <p:origin x="26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63696D-816E-A841-BDBE-B3DB8D31574B}"/>
              </a:ext>
            </a:extLst>
          </p:cNvPr>
          <p:cNvSpPr txBox="1">
            <a:spLocks/>
          </p:cNvSpPr>
          <p:nvPr/>
        </p:nvSpPr>
        <p:spPr>
          <a:xfrm>
            <a:off x="0" y="49936"/>
            <a:ext cx="2869324" cy="40293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D2D45F2-8D40-FE42-A82A-AD3C0ADD35C6}"/>
              </a:ext>
            </a:extLst>
          </p:cNvPr>
          <p:cNvSpPr txBox="1"/>
          <p:nvPr/>
        </p:nvSpPr>
        <p:spPr>
          <a:xfrm>
            <a:off x="-6185" y="374182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4D9C1956-C4FE-8B4C-A889-6038099B745E}"/>
              </a:ext>
            </a:extLst>
          </p:cNvPr>
          <p:cNvGrpSpPr/>
          <p:nvPr/>
        </p:nvGrpSpPr>
        <p:grpSpPr>
          <a:xfrm>
            <a:off x="303970" y="566416"/>
            <a:ext cx="6075108" cy="3088400"/>
            <a:chOff x="250630" y="566416"/>
            <a:chExt cx="6075108" cy="308840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DC4AF6D-113D-FE4E-B1FE-8E509D7E6EFB}"/>
                </a:ext>
              </a:extLst>
            </p:cNvPr>
            <p:cNvGrpSpPr/>
            <p:nvPr/>
          </p:nvGrpSpPr>
          <p:grpSpPr>
            <a:xfrm>
              <a:off x="361123" y="566416"/>
              <a:ext cx="1439471" cy="1697363"/>
              <a:chOff x="5147667" y="2506433"/>
              <a:chExt cx="1729157" cy="2242138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AABFE49A-87C6-5043-8869-CA77321D0C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47667" y="2885395"/>
                <a:ext cx="1729157" cy="1863176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2B253269-868C-5F4F-99FD-3CADAA30E698}"/>
                  </a:ext>
                </a:extLst>
              </p:cNvPr>
              <p:cNvSpPr txBox="1"/>
              <p:nvPr/>
            </p:nvSpPr>
            <p:spPr>
              <a:xfrm>
                <a:off x="5182304" y="2506433"/>
                <a:ext cx="1617889" cy="3862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pithelial cells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BF3F9048-9E3C-D04B-9134-DE808EFE3F8F}"/>
                </a:ext>
              </a:extLst>
            </p:cNvPr>
            <p:cNvGrpSpPr/>
            <p:nvPr/>
          </p:nvGrpSpPr>
          <p:grpSpPr>
            <a:xfrm>
              <a:off x="2133503" y="568684"/>
              <a:ext cx="4192235" cy="3086132"/>
              <a:chOff x="1787805" y="5340350"/>
              <a:chExt cx="6062548" cy="4361637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6B6A44EC-69C5-CB4F-9082-C9E4629086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88097" y="5646537"/>
                <a:ext cx="1954234" cy="1862628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CD98C636-64D6-2A42-A24B-DDF0608754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827098" y="7828704"/>
                <a:ext cx="1954234" cy="1862628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8EE31B3B-178C-564F-B9E3-0585396AF6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827097" y="5648172"/>
                <a:ext cx="1954234" cy="1862628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FEA85252-F90B-F641-B483-D91CFCAA989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896119" y="5646537"/>
                <a:ext cx="1954234" cy="1862628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8A139AC0-A103-DC4C-8D54-65DCC972A7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787805" y="7839358"/>
                <a:ext cx="1954235" cy="1862629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C9286DF-A4B3-9340-BC4E-147F42207B6C}"/>
                  </a:ext>
                </a:extLst>
              </p:cNvPr>
              <p:cNvSpPr txBox="1"/>
              <p:nvPr/>
            </p:nvSpPr>
            <p:spPr>
              <a:xfrm>
                <a:off x="1957869" y="5344360"/>
                <a:ext cx="1389042" cy="347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73 (</a:t>
                </a:r>
                <a:r>
                  <a:rPr lang="en-US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T5E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72EF36C-8EBE-C948-A057-34C7F89543BA}"/>
                  </a:ext>
                </a:extLst>
              </p:cNvPr>
              <p:cNvSpPr txBox="1"/>
              <p:nvPr/>
            </p:nvSpPr>
            <p:spPr>
              <a:xfrm>
                <a:off x="4295711" y="5340350"/>
                <a:ext cx="739958" cy="347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ZEB1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FEADCA1-28CF-0749-B7D7-24DE665B30CD}"/>
                  </a:ext>
                </a:extLst>
              </p:cNvPr>
              <p:cNvSpPr txBox="1"/>
              <p:nvPr/>
            </p:nvSpPr>
            <p:spPr>
              <a:xfrm>
                <a:off x="6428503" y="5343934"/>
                <a:ext cx="781685" cy="347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LUG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67C989B-BDD7-8046-9A25-A732DB5A0589}"/>
                  </a:ext>
                </a:extLst>
              </p:cNvPr>
              <p:cNvSpPr txBox="1"/>
              <p:nvPr/>
            </p:nvSpPr>
            <p:spPr>
              <a:xfrm>
                <a:off x="1918524" y="7538924"/>
                <a:ext cx="1535088" cy="347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IBRONECTIN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DA33659-A04D-F146-A267-881CBD2248DA}"/>
                  </a:ext>
                </a:extLst>
              </p:cNvPr>
              <p:cNvSpPr txBox="1"/>
              <p:nvPr/>
            </p:nvSpPr>
            <p:spPr>
              <a:xfrm>
                <a:off x="4065764" y="7536568"/>
                <a:ext cx="1484088" cy="347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-CADHERIN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61374DA0-7ABB-CA44-A72E-C12E936B485F}"/>
                  </a:ext>
                </a:extLst>
              </p:cNvPr>
              <p:cNvSpPr/>
              <p:nvPr/>
            </p:nvSpPr>
            <p:spPr>
              <a:xfrm>
                <a:off x="1886920" y="6741258"/>
                <a:ext cx="355801" cy="40144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72BDCC99-D00C-8346-BC84-CBFB1AFD7713}"/>
                  </a:ext>
                </a:extLst>
              </p:cNvPr>
              <p:cNvSpPr/>
              <p:nvPr/>
            </p:nvSpPr>
            <p:spPr>
              <a:xfrm>
                <a:off x="3921995" y="6741258"/>
                <a:ext cx="355801" cy="40144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7A89A67B-2FD3-F146-92F3-BB7AD9207039}"/>
                  </a:ext>
                </a:extLst>
              </p:cNvPr>
              <p:cNvSpPr/>
              <p:nvPr/>
            </p:nvSpPr>
            <p:spPr>
              <a:xfrm>
                <a:off x="6019275" y="6741258"/>
                <a:ext cx="355801" cy="40144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E24257D5-42C3-4E4E-9841-2CD9A9793012}"/>
                  </a:ext>
                </a:extLst>
              </p:cNvPr>
              <p:cNvSpPr/>
              <p:nvPr/>
            </p:nvSpPr>
            <p:spPr>
              <a:xfrm>
                <a:off x="1897221" y="8864967"/>
                <a:ext cx="355800" cy="40144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F81CD181-895C-AA41-961A-7474379C5FD0}"/>
                  </a:ext>
                </a:extLst>
              </p:cNvPr>
              <p:cNvSpPr/>
              <p:nvPr/>
            </p:nvSpPr>
            <p:spPr>
              <a:xfrm>
                <a:off x="3939911" y="8864966"/>
                <a:ext cx="355800" cy="40144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0CA5750F-B754-3C4D-AB5C-E4EDBC084792}"/>
                </a:ext>
              </a:extLst>
            </p:cNvPr>
            <p:cNvGrpSpPr/>
            <p:nvPr/>
          </p:nvGrpSpPr>
          <p:grpSpPr>
            <a:xfrm>
              <a:off x="250630" y="2433694"/>
              <a:ext cx="1836540" cy="1147707"/>
              <a:chOff x="303970" y="2433694"/>
              <a:chExt cx="1836540" cy="1147707"/>
            </a:xfrm>
          </p:grpSpPr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E2A111CB-5213-5947-8CD5-3B77F4F01B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678" t="23885" r="82753" b="63172"/>
              <a:stretch/>
            </p:blipFill>
            <p:spPr>
              <a:xfrm>
                <a:off x="339184" y="2433694"/>
                <a:ext cx="224696" cy="256605"/>
              </a:xfrm>
              <a:prstGeom prst="rect">
                <a:avLst/>
              </a:prstGeom>
            </p:spPr>
          </p:pic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C0CF0020-CB16-E043-9B72-ED28C50801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3737" t="51153" r="82859" b="5903"/>
              <a:stretch/>
            </p:blipFill>
            <p:spPr>
              <a:xfrm>
                <a:off x="303970" y="2704501"/>
                <a:ext cx="259910" cy="876900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F20187F-6ABF-AA43-A118-144407E073B9}"/>
                  </a:ext>
                </a:extLst>
              </p:cNvPr>
              <p:cNvSpPr txBox="1"/>
              <p:nvPr/>
            </p:nvSpPr>
            <p:spPr>
              <a:xfrm>
                <a:off x="503639" y="2433694"/>
                <a:ext cx="16065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 Basal    (n=4312)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95A46674-7931-2E41-A1A3-57B82E0A2B36}"/>
                  </a:ext>
                </a:extLst>
              </p:cNvPr>
              <p:cNvSpPr txBox="1"/>
              <p:nvPr/>
            </p:nvSpPr>
            <p:spPr>
              <a:xfrm>
                <a:off x="513789" y="2741945"/>
                <a:ext cx="15985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 HER2+ (n=3708)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D3758AB-9D08-784A-B50F-D77F833E9D84}"/>
                  </a:ext>
                </a:extLst>
              </p:cNvPr>
              <p:cNvSpPr txBox="1"/>
              <p:nvPr/>
            </p:nvSpPr>
            <p:spPr>
              <a:xfrm>
                <a:off x="513789" y="3025610"/>
                <a:ext cx="16209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 Lum A   (n=7742)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F1F99D89-A9BB-AB48-8207-0BC2CB8E020D}"/>
                  </a:ext>
                </a:extLst>
              </p:cNvPr>
              <p:cNvSpPr txBox="1"/>
              <p:nvPr/>
            </p:nvSpPr>
            <p:spPr>
              <a:xfrm>
                <a:off x="519553" y="3303505"/>
                <a:ext cx="16209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 Lum B   (n=3368)</a:t>
                </a:r>
              </a:p>
            </p:txBody>
          </p:sp>
        </p:grp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BAFE17D5-08F4-C443-9BD7-D937216EBA44}"/>
              </a:ext>
            </a:extLst>
          </p:cNvPr>
          <p:cNvSpPr txBox="1"/>
          <p:nvPr/>
        </p:nvSpPr>
        <p:spPr>
          <a:xfrm>
            <a:off x="65739" y="3997514"/>
            <a:ext cx="70780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i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8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D73 expression on human breast cancer patient samples</a:t>
            </a:r>
            <a:r>
              <a:rPr lang="en-US" sz="1200" b="1" dirty="0">
                <a:latin typeface="Times" pitchFamily="2" charset="0"/>
                <a:ea typeface="Times" pitchFamily="2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scRNA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Calibri" panose="020F0502020204030204" pitchFamily="34" charset="0"/>
                <a:cs typeface="Arial" panose="020B0604020202020204" pitchFamily="34" charset="0"/>
              </a:rPr>
              <a:t>-Seq transcriptomic data of human breast tumors obtained from ref 28 were analyzed in the single cell portal after specifically selecting for epithelial cancer cells belonging to the basal, HER2+, Luminal A or Luminal B subsets where n represents the number of cells in each subset. UMAP plots for the indicated markers are represented for each of these subsets. </a:t>
            </a:r>
            <a:endParaRPr lang="en-US" sz="12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65889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2</TotalTime>
  <Words>124</Words>
  <Application>Microsoft Macintosh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8</cp:revision>
  <dcterms:created xsi:type="dcterms:W3CDTF">2023-02-11T23:37:55Z</dcterms:created>
  <dcterms:modified xsi:type="dcterms:W3CDTF">2026-05-11T01:32:24Z</dcterms:modified>
</cp:coreProperties>
</file>